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6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A7A903-A1C7-4FFD-A79B-300644E3DE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24989-6CFC-41F0-8C02-65E76007E3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B2E930-32B2-4A85-9371-FBC45FC67F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9A316-61E5-4E61-8D0B-409C39CDB0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0249B4-ACBD-4520-B570-AEE0FF845E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F60591-2287-432F-B7AF-F88FB77C7E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81B16B-A14E-4407-A575-DA53D1390E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D26E6A-CA4E-48B1-829B-D86E6817FE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A69E3C-700D-490A-BA4E-50BB771133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C402B-FABD-476A-81F1-CDBFBA94B9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9A6CA-57AA-4115-BE2D-11BE65D43D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91E4D0-BD20-45B2-B5F5-CD5C9176B2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09A940-477A-4F35-8FDD-4012047885ED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oleObject" Target="../embeddings/oleObject1.bin"/><Relationship Id="rId4" Type="http://schemas.openxmlformats.org/officeDocument/2006/relationships/image" Target="../media/image3.png"/><Relationship Id="rId5" Type="http://schemas.openxmlformats.org/officeDocument/2006/relationships/oleObject" Target="../embeddings/oleObject2.bin"/><Relationship Id="rId6" Type="http://schemas.openxmlformats.org/officeDocument/2006/relationships/image" Target="../media/image4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6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90960" y="324000"/>
            <a:ext cx="4429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Testing the specificity of the anti LASP-1 antibod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836640" y="1476360"/>
            <a:ext cx="2313000" cy="154152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3500280" y="1476360"/>
            <a:ext cx="2313000" cy="15415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404280" y="2916360"/>
            <a:ext cx="583200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LASP-1 immunostaining of human breast cancer tissue befor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(A) and after (B) LASP-1antibody preabsorption showing th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specificity of the LASP-1 antibody (magnification x40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838440" y="14763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502080" y="14763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28320" y="7380360"/>
            <a:ext cx="644328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Full LASP-1 Western Blot (C) of the human breast cancer cell li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BT20  before (Control) and after (siRNA) LASP-1 knockdown show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the specificity of the LASP-1 antibody. Equal loading was controlled b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ß-actin Western blot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8" name=""/>
          <p:cNvGraphicFramePr/>
          <p:nvPr/>
        </p:nvGraphicFramePr>
        <p:xfrm>
          <a:off x="1844640" y="4500720"/>
          <a:ext cx="936720" cy="17287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844640" y="4500720"/>
                    <a:ext cx="936720" cy="1728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0" name=""/>
          <p:cNvGraphicFramePr/>
          <p:nvPr/>
        </p:nvGraphicFramePr>
        <p:xfrm>
          <a:off x="1844640" y="6300720"/>
          <a:ext cx="936720" cy="4366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1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844640" y="6300720"/>
                    <a:ext cx="936720" cy="436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2" name=""/>
          <p:cNvSpPr/>
          <p:nvPr/>
        </p:nvSpPr>
        <p:spPr>
          <a:xfrm rot="16200000">
            <a:off x="1663200" y="6986520"/>
            <a:ext cx="81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800280" y="4148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6200000">
            <a:off x="2145600" y="6937560"/>
            <a:ext cx="71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933280" y="5184720"/>
            <a:ext cx="81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ASP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H="1">
            <a:off x="2781360" y="536400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H="1">
            <a:off x="2781360" y="651672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946240" y="6346800"/>
            <a:ext cx="793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ß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568520" y="4667400"/>
            <a:ext cx="288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568520" y="5027760"/>
            <a:ext cx="288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568520" y="5315040"/>
            <a:ext cx="288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568520" y="5675400"/>
            <a:ext cx="288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568520" y="5964120"/>
            <a:ext cx="288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282320" y="45226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282320" y="48830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282320" y="51721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282320" y="55306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282320" y="58197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282320" y="4307040"/>
            <a:ext cx="506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197000" y="4284720"/>
            <a:ext cx="2519280" cy="3240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"/>
          <p:cNvSpPr/>
          <p:nvPr/>
        </p:nvSpPr>
        <p:spPr>
          <a:xfrm>
            <a:off x="393120" y="635040"/>
            <a:ext cx="3963240" cy="125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Supplemental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Testing the specificity of anti-PDEF antibod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603360" y="6084720"/>
            <a:ext cx="599940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(A) Full PDEF Western Blot of 10 µg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protein prepared from PDEF positiv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prostate cancer cell lines and PDEF negative cells (platelets, HUVEC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showing the specificity of the PDEF antibody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(B) PDEF immunohistochemistry in primary prostate carcinom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3" name=""/>
          <p:cNvGrpSpPr/>
          <p:nvPr/>
        </p:nvGrpSpPr>
        <p:grpSpPr>
          <a:xfrm>
            <a:off x="622080" y="2124000"/>
            <a:ext cx="2566080" cy="3392640"/>
            <a:chOff x="622080" y="2124000"/>
            <a:chExt cx="2566080" cy="3392640"/>
          </a:xfrm>
        </p:grpSpPr>
        <p:graphicFrame>
          <p:nvGraphicFramePr>
            <p:cNvPr id="74" name=""/>
            <p:cNvGraphicFramePr/>
            <p:nvPr/>
          </p:nvGraphicFramePr>
          <p:xfrm>
            <a:off x="1501920" y="2428560"/>
            <a:ext cx="1657080" cy="205128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75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501920" y="2428560"/>
                      <a:ext cx="1657080" cy="2051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6" name=""/>
            <p:cNvSpPr/>
            <p:nvPr/>
          </p:nvSpPr>
          <p:spPr>
            <a:xfrm rot="16200000">
              <a:off x="1274040" y="4703400"/>
              <a:ext cx="762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LNCa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rot="16200000">
              <a:off x="1679400" y="4573440"/>
              <a:ext cx="52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PC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rot="16200000">
              <a:off x="1969920" y="4556160"/>
              <a:ext cx="52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RV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rot="16200000">
              <a:off x="2207160" y="4746960"/>
              <a:ext cx="91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Platelet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rot="16200000">
              <a:off x="2595240" y="4680720"/>
              <a:ext cx="793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HUVEV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563840" y="5236920"/>
              <a:ext cx="793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525680" y="5240160"/>
              <a:ext cx="834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Prostate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212840" y="2644560"/>
              <a:ext cx="289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212840" y="3004920"/>
              <a:ext cx="289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177920" y="3342960"/>
              <a:ext cx="289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212840" y="3652560"/>
              <a:ext cx="289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212840" y="3941640"/>
              <a:ext cx="289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926640" y="250020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7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926640" y="286056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926640" y="350820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3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926640" y="379728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926640" y="2284200"/>
              <a:ext cx="506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622080" y="3171600"/>
              <a:ext cx="704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PDEF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424160" y="2124000"/>
              <a:ext cx="176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10 µg protein per lan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" name=""/>
          <p:cNvSpPr/>
          <p:nvPr/>
        </p:nvSpPr>
        <p:spPr>
          <a:xfrm>
            <a:off x="476280" y="1763640"/>
            <a:ext cx="30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76280" y="1781280"/>
            <a:ext cx="2825640" cy="3960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"/>
          <p:cNvGrpSpPr/>
          <p:nvPr/>
        </p:nvGrpSpPr>
        <p:grpSpPr>
          <a:xfrm>
            <a:off x="3573360" y="1763640"/>
            <a:ext cx="2444760" cy="1871640"/>
            <a:chOff x="3573360" y="1763640"/>
            <a:chExt cx="2444760" cy="1871640"/>
          </a:xfrm>
        </p:grpSpPr>
        <p:graphicFrame>
          <p:nvGraphicFramePr>
            <p:cNvPr id="98" name=""/>
            <p:cNvGraphicFramePr/>
            <p:nvPr/>
          </p:nvGraphicFramePr>
          <p:xfrm>
            <a:off x="3573360" y="1763640"/>
            <a:ext cx="2444760" cy="187164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99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573360" y="1763640"/>
                      <a:ext cx="2444760" cy="1871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00" name=""/>
            <p:cNvSpPr/>
            <p:nvPr/>
          </p:nvSpPr>
          <p:spPr>
            <a:xfrm>
              <a:off x="3575160" y="176364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"/>
          <p:cNvSpPr/>
          <p:nvPr/>
        </p:nvSpPr>
        <p:spPr>
          <a:xfrm>
            <a:off x="3574080" y="3348000"/>
            <a:ext cx="46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x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19T10:22:43Z</dcterms:created>
  <dc:creator>Butt</dc:creator>
  <dc:description/>
  <dc:language>en-US</dc:language>
  <cp:lastModifiedBy>Butt</cp:lastModifiedBy>
  <dcterms:modified xsi:type="dcterms:W3CDTF">2010-03-25T13:12:48Z</dcterms:modified>
  <cp:revision>14</cp:revision>
  <dc:subject/>
  <dc:title>Folie 1</dc:title>
</cp:coreProperties>
</file>